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005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372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7918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680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749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821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572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131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68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5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420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ABF264-BE65-4B28-AC86-92932D0C3938}" type="datetimeFigureOut">
              <a:rPr lang="en-US" smtClean="0"/>
              <a:t>3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BC241-436E-4676-82DC-277860E3C4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191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8851905"/>
              </p:ext>
            </p:extLst>
          </p:nvPr>
        </p:nvGraphicFramePr>
        <p:xfrm>
          <a:off x="83128" y="83127"/>
          <a:ext cx="11490035" cy="66507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258350">
                  <a:extLst>
                    <a:ext uri="{9D8B030D-6E8A-4147-A177-3AD203B41FA5}">
                      <a16:colId xmlns:a16="http://schemas.microsoft.com/office/drawing/2014/main" val="2482423206"/>
                    </a:ext>
                  </a:extLst>
                </a:gridCol>
                <a:gridCol w="2743895">
                  <a:extLst>
                    <a:ext uri="{9D8B030D-6E8A-4147-A177-3AD203B41FA5}">
                      <a16:colId xmlns:a16="http://schemas.microsoft.com/office/drawing/2014/main" val="2218701499"/>
                    </a:ext>
                  </a:extLst>
                </a:gridCol>
                <a:gridCol w="2743895">
                  <a:extLst>
                    <a:ext uri="{9D8B030D-6E8A-4147-A177-3AD203B41FA5}">
                      <a16:colId xmlns:a16="http://schemas.microsoft.com/office/drawing/2014/main" val="3742982246"/>
                    </a:ext>
                  </a:extLst>
                </a:gridCol>
                <a:gridCol w="2743895">
                  <a:extLst>
                    <a:ext uri="{9D8B030D-6E8A-4147-A177-3AD203B41FA5}">
                      <a16:colId xmlns:a16="http://schemas.microsoft.com/office/drawing/2014/main" val="571108673"/>
                    </a:ext>
                  </a:extLst>
                </a:gridCol>
              </a:tblGrid>
              <a:tr h="133436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5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All</a:t>
                      </a:r>
                      <a:r>
                        <a:rPr lang="en-US" sz="1050" b="1" i="0" u="none" strike="noStrike" baseline="0" dirty="0" smtClean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 Concomitant Medications taken by NHS Cohort (*</a:t>
                      </a:r>
                      <a:r>
                        <a:rPr lang="en-US" sz="1050" b="1" i="0" u="none" strike="noStrike" baseline="0" dirty="0" err="1" smtClean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Cardioactive</a:t>
                      </a:r>
                      <a:r>
                        <a:rPr lang="en-US" sz="1050" b="1" i="0" u="none" strike="noStrike" baseline="0" dirty="0" smtClean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 Drugs)</a:t>
                      </a:r>
                      <a:endParaRPr lang="en-US" sz="105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/>
                </a:tc>
                <a:extLst>
                  <a:ext uri="{0D108BD9-81ED-4DB2-BD59-A6C34878D82A}">
                    <a16:rowId xmlns:a16="http://schemas.microsoft.com/office/drawing/2014/main" val="3935168525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ACETYLCYSTE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HLORHEXID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YDROCORTISONE BUTYR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HLOROGLUCINO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74437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CETYLSALICYLIC AC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HLORMADINONE ACET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BUPROFE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OTASSIUM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CHLOR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5069246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CICLOVIR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HLORZOXAZO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IMATINIB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RAMIPEXOLE DI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8957158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LIMEMAZINE TARTR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ILEST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IMIPRAM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REDNISO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200874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LL OTHER THERAPEUTIC PRODUCT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CIPROFLOXACIN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INDOMETAC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REGABAL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2666740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MITRIPTYL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LARITHROMYC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INFLUENZA VACC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RIDIN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701228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AMLODIPIN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LINDAMYC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LACTOBACILLUS BULGARICU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ROBIOTICS NO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8356317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MOXICILL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LOMIPRAM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LAMOTRIG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SEUDOEPHEDRIN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252425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MOXICILLIN TRIHYDR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LONAZEPA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LANSOPRAZOL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PSEUDOEPHEDRINE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HYDROCHLOR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2044745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NASTROZOL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CLONIDINE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HYDROCHLOR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LEVOFLOXACIN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QUETIAPIN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3316208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NTACID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OCOS NUCIFERA OI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LIDOCAIN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RANITID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1517752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NTIBIOTIC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ODE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PERAM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RANITID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5642797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ANTIEPILEPTICS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OLECALCIFERO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LORAZEPAM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RETINOIDS FOR TREATMENT OF AC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7204136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ANTIHISTAMINES FOR SYSTEMIC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US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COMBIVENT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LATON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RIZATRIPTAN BENZO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3608332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NTIINFLAMMATORY AND ANTIRHEUMATIC PRODUCT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ORTICOSTEROIDS FOR SYSTEMIC USE, PLA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MELOXICAM;PRIDIN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ACCHAROMYCES BOULARDII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9438326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NTIINFLAMMATORY PREPARATIONS, NON-STEROIDS F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ROMOGLICATE SODIU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MENTH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ALBUTAM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435750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PIGEN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URCUMA LONGA RHIZOM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METHOTREX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ALBUTAMOL SULF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704687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RIPIPRAZOL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YANOCOBALAM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ETHYLPHENIDAT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ALICYLIC ACID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4127769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RNICA MONTANA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YCLOBENZAPR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HYLPHENIDATE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HYDROCHLOR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SERET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600220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SCORBIC AC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YSTINE W/RETINOL ACETATE/SACCHAROMYCES CEREV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HYLPREDNISOLO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ERTRAL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295291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SCORBIC ACID W/BIOFLAVONOIDS/MAGNESIUM HYDRO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ESOGESTRE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HYLPREDNISOLONE SODIUM SUCCIN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ERTRAL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638577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SCORBIC ACID W/HERBAL NOS/LEVOGLUTAMIDE/LYSI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EXTROMETHORPHA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METOCLOPRAMID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HARK-LIVER OI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431990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SCORBIC ACID W/ROSA CANINA/SODIUM ASCORB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IA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ETOPIMAZ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ILDENAFI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2524517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SCORBIC ACID;BACILLUS </a:t>
                      </a:r>
                      <a:r>
                        <a:rPr lang="en-US" sz="900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COAGULAN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DIAZEPAM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INERALS NOS W/VITAMINS NO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ODIUM 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221032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TORVASTAT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DICLOFENAC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OMETASONE FURO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PASFON 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5277428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AZITHROMYC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OLOBE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ONTELUKAST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PEKTRAMOX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110526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ACLOFE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OXYCYCL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ULTIVITAMINS, OTHER COMBINATION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PIRAMYC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0905462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ACTRI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DULOXET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MUSCLE RELAXANT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UCRALF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255064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ENZODIAZEPINE DERIVATIVE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LETRIPTA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APROXE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SULTIAM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153979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BIO GRIP </a:t>
                      </a:r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DESCONGESTIVO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LETRIPTAN HYDROBROM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ICOTINAMID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SUMATRIPTA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924672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ISPHOSPHONATE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EPINEPHRINE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NITROFURANTO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TAMSULOSIN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1996799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UDESON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SCITALOPRAM OXAL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NORLESTRIN F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THALIDOM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062320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BUTYLSCOPOLAM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SOMEPRAZOL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NSAID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HIOCTIC AC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463822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LCITRI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SOMEPRAZOLE MAGNESIU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OFLOXACIN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TIZANID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423735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LCIU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THOSUXIM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MEGA-3 FATTY ACID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OCOPHEROL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001381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LCIUM CARBON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TORICOXIB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MEPRAZOL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TRAMAD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119907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MELLIA SINENSI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EVRA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NDANSETRO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ETINOI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363003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NNABIS SATIVA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ERROUS BISGLYCIN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PIOID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IAMCINOLO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8798964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NNABIS SATIVA OI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ISH OI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RAL CONTRACEPTIVE NOS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TRIMEBUTIN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157820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ARBAMAZEP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LUOXET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SELTAMIVIR PHOSPH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ACCINIUM MACROCARPON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6666608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FALEX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LUTICASONE PROPIONAT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XCARBAZEPI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ALPROATE SEMISODIUM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123862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FDINIR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OLIC ACID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OXYBUTYN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ALPROIC AC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4961295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FPODOXIME PROXETI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FUSIDIC ACID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AMIDRONATE DISODIU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ITAMIN D NO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941445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FTRIAXON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GABAPENT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ANCREATI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VITAMINS NOS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2341811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LECOXIB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HERBAL PREPARATIO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ANTOPRAZOL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ZINC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1683747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ETIRIZ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HOMEOPATHIC PREPARATION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ARACETAMOL*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solidFill>
                            <a:schemeClr val="tx1"/>
                          </a:solidFill>
                          <a:effectLst/>
                        </a:rPr>
                        <a:t>ZOLEDRONIC ACID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5498403"/>
                  </a:ext>
                </a:extLst>
              </a:tr>
              <a:tr h="13343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CHLORAMPHENICOL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HOPANTENATE CALCIUM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solidFill>
                            <a:schemeClr val="tx1"/>
                          </a:solidFill>
                          <a:effectLst/>
                        </a:rPr>
                        <a:t>PHENAZOPYRIDINE HYDROCHLORIDE</a:t>
                      </a:r>
                      <a:endParaRPr lang="en-US" sz="9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2" marR="922" marT="92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1556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58827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9</TotalTime>
  <Words>334</Words>
  <Application>Microsoft Office PowerPoint</Application>
  <PresentationFormat>Widescreen</PresentationFormat>
  <Paragraphs>1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Kou, Samuel</cp:lastModifiedBy>
  <cp:revision>6</cp:revision>
  <dcterms:created xsi:type="dcterms:W3CDTF">2020-03-12T18:29:56Z</dcterms:created>
  <dcterms:modified xsi:type="dcterms:W3CDTF">2020-03-13T18:49:33Z</dcterms:modified>
</cp:coreProperties>
</file>